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56" r:id="rId2"/>
    <p:sldId id="257" r:id="rId3"/>
    <p:sldId id="258" r:id="rId4"/>
    <p:sldId id="259" r:id="rId5"/>
    <p:sldId id="260" r:id="rId6"/>
    <p:sldId id="261" r:id="rId7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83" autoAdjust="0"/>
    <p:restoredTop sz="94630"/>
  </p:normalViewPr>
  <p:slideViewPr>
    <p:cSldViewPr snapToGrid="0">
      <p:cViewPr varScale="1">
        <p:scale>
          <a:sx n="113" d="100"/>
          <a:sy n="113" d="100"/>
        </p:scale>
        <p:origin x="56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7A79E5D-2F4C-4F79-8A0A-C77EF2E39524}" type="datetimeFigureOut">
              <a:rPr lang="fr-FR" smtClean="0"/>
              <a:t>16/05/2024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4CA20E7-0F40-4C6A-A13D-2891916D495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276494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4CA20E7-0F40-4C6A-A13D-2891916D4955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243445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5AB6A26-DF3D-5740-CCE3-C9490E659E6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EA05135C-BC99-828F-7BAE-49089336A50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E629169-17D6-07E3-2F73-D7D759361C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BA7697-6FC6-406B-81C8-255C48D706C4}" type="datetimeFigureOut">
              <a:rPr lang="fr-FR" smtClean="0"/>
              <a:t>16/05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4FCE173-642D-F5C9-35B2-A2B00BA4A9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7FF95F5-DF7A-13B6-B4B3-73108A0D4B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2AF600-66BE-4E11-92F6-5739079D1A1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852900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F6F5B2D-3383-BDF8-8156-232700D048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D73E509D-E221-A977-D73C-2D0B25065D1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AE2C46C-088D-FDF0-4650-5A2320537F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BA7697-6FC6-406B-81C8-255C48D706C4}" type="datetimeFigureOut">
              <a:rPr lang="fr-FR" smtClean="0"/>
              <a:t>16/05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FCF1A37-E617-5F0C-23D1-742AB946DB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E132080-DB6D-2130-5D3C-1B31451DD0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2AF600-66BE-4E11-92F6-5739079D1A1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942722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488205B8-BA50-0D82-8B75-01E5831E973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7B451444-8888-D602-3AD2-234A08D5E85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463372A-7807-8C51-E5A6-E3F176BA79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BA7697-6FC6-406B-81C8-255C48D706C4}" type="datetimeFigureOut">
              <a:rPr lang="fr-FR" smtClean="0"/>
              <a:t>16/05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CA76A65-594C-11BC-179F-FA35F8EE2B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E0F4BF0-A76F-79DE-F943-50B5B7AE46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2AF600-66BE-4E11-92F6-5739079D1A1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671951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16D4792-123A-AA4E-358C-04398F7812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E9C916D-65F7-869A-99F8-CFCDCF467C2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D8E7215-AD4B-A23B-30E8-57F90185A7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BA7697-6FC6-406B-81C8-255C48D706C4}" type="datetimeFigureOut">
              <a:rPr lang="fr-FR" smtClean="0"/>
              <a:t>16/05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8ACAB32-C2F6-A768-B6EE-FB4D4CC5F1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8765091-104E-7AF9-266A-D4D85F1C89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2AF600-66BE-4E11-92F6-5739079D1A1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280187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CFFB23A-645C-D4DA-E394-C02CDEB29F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77408666-28B2-3F0A-F3F0-583D54D548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E68F81D-FB1C-5D32-2ECA-36AD02035E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BA7697-6FC6-406B-81C8-255C48D706C4}" type="datetimeFigureOut">
              <a:rPr lang="fr-FR" smtClean="0"/>
              <a:t>16/05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1D09000-734D-1990-921E-8CF7D35437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BB5C60B-93F2-DF0F-98A6-CED7804F0A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2AF600-66BE-4E11-92F6-5739079D1A1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596799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D73169B-5489-F306-AC03-39F894EADD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47CB4C71-DA28-2EE1-A862-1C88E91C72B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C6A6165E-D58F-C76C-DC8F-37473E0B9C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A681E81-E098-42AB-129E-876431B570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BA7697-6FC6-406B-81C8-255C48D706C4}" type="datetimeFigureOut">
              <a:rPr lang="fr-FR" smtClean="0"/>
              <a:t>16/05/2024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15E40E7E-0DA0-A489-6CC5-58DE4B519B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E111EA9-4827-E0FB-A68F-60066B7925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2AF600-66BE-4E11-92F6-5739079D1A1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487681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20DFD02-EFA8-AA86-ACB5-155498E38D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AEA6BA7B-C919-962F-57DF-8149D72A38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A91BF597-81FE-4A31-822E-D596715CE24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FE24003E-C243-24AB-41CD-1CA732A60FB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3C871A96-CA6A-2FEB-ED47-99CF67A75DC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7685E9AA-5085-5295-6152-C977C38D3A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BA7697-6FC6-406B-81C8-255C48D706C4}" type="datetimeFigureOut">
              <a:rPr lang="fr-FR" smtClean="0"/>
              <a:t>16/05/2024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EF37BCB1-F36D-2BD6-F9D0-5E8769F5CD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F1CD39CA-4717-0C46-9348-C5D11A10C3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2AF600-66BE-4E11-92F6-5739079D1A1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795783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1F845E0-AE96-52AF-5DF0-4631BF6E9D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8524F3D5-D6AB-FEB7-2715-B293AD74EF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BA7697-6FC6-406B-81C8-255C48D706C4}" type="datetimeFigureOut">
              <a:rPr lang="fr-FR" smtClean="0"/>
              <a:t>16/05/2024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41090A2B-956E-13A5-3C11-EFA1C2CE14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68AF6D40-A686-73FB-643C-B08D70F08F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2AF600-66BE-4E11-92F6-5739079D1A1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497381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BC5A047D-E861-5A2B-7D7C-7CBCB35CED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BA7697-6FC6-406B-81C8-255C48D706C4}" type="datetimeFigureOut">
              <a:rPr lang="fr-FR" smtClean="0"/>
              <a:t>16/05/2024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AA0FAEB8-15EC-E136-F2F7-8241BC55A1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85201366-B926-9129-F11A-0752C7B1B9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2AF600-66BE-4E11-92F6-5739079D1A1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920132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A65EF3C-2594-DAC6-A73D-AA3B8C0631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CCDBA0A8-FCD8-A21E-B3A6-F3C4BCC864E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AA4A56E4-D756-1499-4508-B8CE2091F57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06BC5F68-5912-91A4-D4FD-1C8E843BB7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BA7697-6FC6-406B-81C8-255C48D706C4}" type="datetimeFigureOut">
              <a:rPr lang="fr-FR" smtClean="0"/>
              <a:t>16/05/2024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1266AC43-E03A-20E9-E03B-64AEA48C3D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F8525B8B-C0E5-4EE5-7825-1039A05440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2AF600-66BE-4E11-92F6-5739079D1A1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452622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770FD24-B202-62B7-8093-7835321738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AA91B901-834C-9D04-415B-D3C078F0589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B4BAB262-0069-F8B2-2ABD-7B6D160EE84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C9A5CAEE-7F50-E42D-0355-74884F40E1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BA7697-6FC6-406B-81C8-255C48D706C4}" type="datetimeFigureOut">
              <a:rPr lang="fr-FR" smtClean="0"/>
              <a:t>16/05/2024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2BE0B9BA-A690-DA05-578F-AC5EB93E73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1FF5EF7A-660A-CCEA-3DD4-76AD287263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2AF600-66BE-4E11-92F6-5739079D1A1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25873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36D8DDCC-B54A-3B61-9575-FD34485EF2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BC3F1226-7DDE-D3D3-C514-0E41A29D92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B12CBE4-3356-FD62-9375-23A70CD4836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ABA7697-6FC6-406B-81C8-255C48D706C4}" type="datetimeFigureOut">
              <a:rPr lang="fr-FR" smtClean="0"/>
              <a:t>16/05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9E9CBC7-2597-16F1-15FF-DC198220D77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2048E8B-984A-D8F0-8F09-9512205BC57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92AF600-66BE-4E11-92F6-5739079D1A1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432365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s://www.uniprot.org/uniprotkb/A0A3B5YYA4/entry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hyperlink" Target="https://www.uniprot.org/uniprotkb/A0A3B6DL62/entry" TargetMode="Externa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hyperlink" Target="https://www.uniprot.org/uniprotkb/A0A3B5ZPA1/entry" TargetMode="Externa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 descr="Une image contenant obscurité, Néon, léger, nuit&#10;&#10;Description générée automatiquement">
            <a:extLst>
              <a:ext uri="{FF2B5EF4-FFF2-40B4-BE49-F238E27FC236}">
                <a16:creationId xmlns:a16="http://schemas.microsoft.com/office/drawing/2014/main" id="{577F0893-B0AA-C4AB-78A8-380198AD347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619" t="8709" r="34415" b="-1425"/>
          <a:stretch/>
        </p:blipFill>
        <p:spPr>
          <a:xfrm>
            <a:off x="3126657" y="139176"/>
            <a:ext cx="5142271" cy="6394982"/>
          </a:xfrm>
          <a:prstGeom prst="rect">
            <a:avLst/>
          </a:prstGeom>
        </p:spPr>
      </p:pic>
      <p:sp>
        <p:nvSpPr>
          <p:cNvPr id="6" name="ZoneTexte 5">
            <a:extLst>
              <a:ext uri="{FF2B5EF4-FFF2-40B4-BE49-F238E27FC236}">
                <a16:creationId xmlns:a16="http://schemas.microsoft.com/office/drawing/2014/main" id="{473251CD-64C7-DA97-81D7-89D2B5DBEDFC}"/>
              </a:ext>
            </a:extLst>
          </p:cNvPr>
          <p:cNvSpPr txBox="1"/>
          <p:nvPr/>
        </p:nvSpPr>
        <p:spPr>
          <a:xfrm>
            <a:off x="4340026" y="4915803"/>
            <a:ext cx="3578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TaDGK1 : </a:t>
            </a:r>
            <a:r>
              <a:rPr lang="fr-FR" sz="1800" u="sng" dirty="0">
                <a:solidFill>
                  <a:srgbClr val="0000FF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hlinkClick r:id="rId4"/>
              </a:rPr>
              <a:t>A0A3B5YYA4</a:t>
            </a:r>
            <a:endParaRPr lang="fr-FR" dirty="0"/>
          </a:p>
        </p:txBody>
      </p:sp>
      <p:pic>
        <p:nvPicPr>
          <p:cNvPr id="2" name="Image 1">
            <a:extLst>
              <a:ext uri="{FF2B5EF4-FFF2-40B4-BE49-F238E27FC236}">
                <a16:creationId xmlns:a16="http://schemas.microsoft.com/office/drawing/2014/main" id="{F2CB8B08-6DDD-C37B-A453-751800D1ED8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9483" y="0"/>
            <a:ext cx="2781300" cy="2578100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E2B6FB08-E5DE-DF6F-20A8-B791ECFAC83C}"/>
              </a:ext>
            </a:extLst>
          </p:cNvPr>
          <p:cNvSpPr txBox="1"/>
          <p:nvPr/>
        </p:nvSpPr>
        <p:spPr>
          <a:xfrm>
            <a:off x="0" y="5918605"/>
            <a:ext cx="12192000" cy="123110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b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Figure S5. </a:t>
            </a:r>
            <a:r>
              <a:rPr lang="fr-FR" sz="1400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Predicted</a:t>
            </a:r>
            <a:r>
              <a:rPr lang="fr-FR" sz="14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structures of TaDGK1, TaDGK5, </a:t>
            </a:r>
            <a:r>
              <a:rPr lang="fr-FR" sz="1400" dirty="0">
                <a:latin typeface="Palatino Linotype" panose="02040502050505030304" pitchFamily="18" charset="0"/>
              </a:rPr>
              <a:t>TaPI-PLC2_1A , </a:t>
            </a:r>
            <a:r>
              <a:rPr lang="fr-FR" sz="14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TaPLD1, TaPLD9 and TaPLD10. The structures </a:t>
            </a:r>
            <a:r>
              <a:rPr lang="fr-FR" sz="1400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were</a:t>
            </a:r>
            <a:r>
              <a:rPr lang="fr-FR" sz="14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</a:t>
            </a:r>
            <a:r>
              <a:rPr lang="fr-FR" sz="1400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predicted</a:t>
            </a:r>
            <a:r>
              <a:rPr lang="fr-FR" sz="14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by </a:t>
            </a:r>
            <a:r>
              <a:rPr lang="fr-FR" sz="1400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Alphafold</a:t>
            </a:r>
            <a:r>
              <a:rPr lang="fr-FR" sz="14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[and </a:t>
            </a:r>
            <a:r>
              <a:rPr lang="fr-FR" sz="1400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represented</a:t>
            </a:r>
            <a:r>
              <a:rPr lang="fr-FR" sz="14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by the </a:t>
            </a:r>
            <a:r>
              <a:rPr lang="fr-FR" sz="1400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PyMOL</a:t>
            </a:r>
            <a:r>
              <a:rPr lang="fr-FR" sz="14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</a:t>
            </a:r>
            <a:r>
              <a:rPr lang="fr-FR" sz="1400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Molecular</a:t>
            </a:r>
            <a:r>
              <a:rPr lang="fr-FR" sz="14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Graphics System, Version 2.0 Schrödinger, LLC. </a:t>
            </a:r>
            <a:r>
              <a:rPr lang="en-US" sz="14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The predicted structures are colored based on the confidence with which each part of the protein is modelled. </a:t>
            </a:r>
            <a:r>
              <a:rPr lang="fr-FR" sz="1400" dirty="0">
                <a:latin typeface="Palatino Linotype" panose="02040502050505030304" pitchFamily="18" charset="0"/>
              </a:rPr>
              <a:t>The </a:t>
            </a:r>
            <a:r>
              <a:rPr lang="fr-FR" sz="1400" dirty="0" err="1">
                <a:latin typeface="Palatino Linotype" panose="02040502050505030304" pitchFamily="18" charset="0"/>
              </a:rPr>
              <a:t>predicted</a:t>
            </a:r>
            <a:r>
              <a:rPr lang="fr-FR" sz="1400" dirty="0">
                <a:latin typeface="Palatino Linotype" panose="02040502050505030304" pitchFamily="18" charset="0"/>
              </a:rPr>
              <a:t> local distance </a:t>
            </a:r>
            <a:r>
              <a:rPr lang="fr-FR" sz="1400" dirty="0" err="1">
                <a:latin typeface="Palatino Linotype" panose="02040502050505030304" pitchFamily="18" charset="0"/>
              </a:rPr>
              <a:t>difference</a:t>
            </a:r>
            <a:r>
              <a:rPr lang="fr-FR" sz="1400" dirty="0">
                <a:latin typeface="Palatino Linotype" panose="02040502050505030304" pitchFamily="18" charset="0"/>
              </a:rPr>
              <a:t> test (</a:t>
            </a:r>
            <a:r>
              <a:rPr lang="fr-FR" sz="1400" dirty="0" err="1">
                <a:latin typeface="Palatino Linotype" panose="02040502050505030304" pitchFamily="18" charset="0"/>
              </a:rPr>
              <a:t>pLDDT</a:t>
            </a:r>
            <a:r>
              <a:rPr lang="fr-FR" sz="1400" dirty="0">
                <a:latin typeface="Palatino Linotype" panose="02040502050505030304" pitchFamily="18" charset="0"/>
              </a:rPr>
              <a:t>) </a:t>
            </a:r>
            <a:r>
              <a:rPr lang="fr-FR" sz="1400" dirty="0" err="1">
                <a:latin typeface="Palatino Linotype" panose="02040502050505030304" pitchFamily="18" charset="0"/>
              </a:rPr>
              <a:t>is</a:t>
            </a:r>
            <a:r>
              <a:rPr lang="fr-FR" sz="1400" dirty="0">
                <a:latin typeface="Palatino Linotype" panose="02040502050505030304" pitchFamily="18" charset="0"/>
              </a:rPr>
              <a:t> a per-</a:t>
            </a:r>
            <a:r>
              <a:rPr lang="fr-FR" sz="1400" dirty="0" err="1">
                <a:latin typeface="Palatino Linotype" panose="02040502050505030304" pitchFamily="18" charset="0"/>
              </a:rPr>
              <a:t>residue</a:t>
            </a:r>
            <a:r>
              <a:rPr lang="fr-FR" sz="1400" dirty="0">
                <a:latin typeface="Palatino Linotype" panose="02040502050505030304" pitchFamily="18" charset="0"/>
              </a:rPr>
              <a:t> </a:t>
            </a:r>
            <a:r>
              <a:rPr lang="fr-FR" sz="1400" dirty="0" err="1">
                <a:latin typeface="Palatino Linotype" panose="02040502050505030304" pitchFamily="18" charset="0"/>
              </a:rPr>
              <a:t>measure</a:t>
            </a:r>
            <a:r>
              <a:rPr lang="fr-FR" sz="1400" dirty="0">
                <a:latin typeface="Palatino Linotype" panose="02040502050505030304" pitchFamily="18" charset="0"/>
              </a:rPr>
              <a:t> of local confidence. It </a:t>
            </a:r>
            <a:r>
              <a:rPr lang="fr-FR" sz="1400" dirty="0" err="1">
                <a:latin typeface="Palatino Linotype" panose="02040502050505030304" pitchFamily="18" charset="0"/>
              </a:rPr>
              <a:t>is</a:t>
            </a:r>
            <a:r>
              <a:rPr lang="fr-FR" sz="1400" dirty="0">
                <a:latin typeface="Palatino Linotype" panose="02040502050505030304" pitchFamily="18" charset="0"/>
              </a:rPr>
              <a:t> </a:t>
            </a:r>
            <a:r>
              <a:rPr lang="fr-FR" sz="1400" dirty="0" err="1">
                <a:latin typeface="Palatino Linotype" panose="02040502050505030304" pitchFamily="18" charset="0"/>
              </a:rPr>
              <a:t>scaled</a:t>
            </a:r>
            <a:r>
              <a:rPr lang="fr-FR" sz="1400" dirty="0">
                <a:latin typeface="Palatino Linotype" panose="02040502050505030304" pitchFamily="18" charset="0"/>
              </a:rPr>
              <a:t> </a:t>
            </a:r>
            <a:r>
              <a:rPr lang="fr-FR" sz="1400" dirty="0" err="1">
                <a:latin typeface="Palatino Linotype" panose="02040502050505030304" pitchFamily="18" charset="0"/>
              </a:rPr>
              <a:t>from</a:t>
            </a:r>
            <a:r>
              <a:rPr lang="fr-FR" sz="1400" dirty="0">
                <a:latin typeface="Palatino Linotype" panose="02040502050505030304" pitchFamily="18" charset="0"/>
              </a:rPr>
              <a:t> 0 to 100, </a:t>
            </a:r>
            <a:r>
              <a:rPr lang="fr-FR" sz="1400" dirty="0" err="1">
                <a:latin typeface="Palatino Linotype" panose="02040502050505030304" pitchFamily="18" charset="0"/>
              </a:rPr>
              <a:t>with</a:t>
            </a:r>
            <a:r>
              <a:rPr lang="fr-FR" sz="1400" dirty="0">
                <a:latin typeface="Palatino Linotype" panose="02040502050505030304" pitchFamily="18" charset="0"/>
              </a:rPr>
              <a:t> </a:t>
            </a:r>
            <a:r>
              <a:rPr lang="fr-FR" sz="1400" dirty="0" err="1">
                <a:latin typeface="Palatino Linotype" panose="02040502050505030304" pitchFamily="18" charset="0"/>
              </a:rPr>
              <a:t>higher</a:t>
            </a:r>
            <a:r>
              <a:rPr lang="fr-FR" sz="1400" dirty="0">
                <a:latin typeface="Palatino Linotype" panose="02040502050505030304" pitchFamily="18" charset="0"/>
              </a:rPr>
              <a:t> scores </a:t>
            </a:r>
            <a:r>
              <a:rPr lang="fr-FR" sz="1400" dirty="0" err="1">
                <a:latin typeface="Palatino Linotype" panose="02040502050505030304" pitchFamily="18" charset="0"/>
              </a:rPr>
              <a:t>indicating</a:t>
            </a:r>
            <a:r>
              <a:rPr lang="fr-FR" sz="1400" dirty="0">
                <a:latin typeface="Palatino Linotype" panose="02040502050505030304" pitchFamily="18" charset="0"/>
              </a:rPr>
              <a:t> </a:t>
            </a:r>
            <a:r>
              <a:rPr lang="fr-FR" sz="1400" dirty="0" err="1">
                <a:latin typeface="Palatino Linotype" panose="02040502050505030304" pitchFamily="18" charset="0"/>
              </a:rPr>
              <a:t>higher</a:t>
            </a:r>
            <a:r>
              <a:rPr lang="fr-FR" sz="1400" dirty="0">
                <a:latin typeface="Palatino Linotype" panose="02040502050505030304" pitchFamily="18" charset="0"/>
              </a:rPr>
              <a:t> confidence and </a:t>
            </a:r>
            <a:r>
              <a:rPr lang="fr-FR" sz="1400" dirty="0" err="1">
                <a:latin typeface="Palatino Linotype" panose="02040502050505030304" pitchFamily="18" charset="0"/>
              </a:rPr>
              <a:t>usually</a:t>
            </a:r>
            <a:r>
              <a:rPr lang="fr-FR" sz="1400" dirty="0">
                <a:latin typeface="Palatino Linotype" panose="02040502050505030304" pitchFamily="18" charset="0"/>
              </a:rPr>
              <a:t> a more </a:t>
            </a:r>
            <a:r>
              <a:rPr lang="fr-FR" sz="1400" dirty="0" err="1">
                <a:latin typeface="Palatino Linotype" panose="02040502050505030304" pitchFamily="18" charset="0"/>
              </a:rPr>
              <a:t>accurate</a:t>
            </a:r>
            <a:r>
              <a:rPr lang="fr-FR" sz="1400" dirty="0">
                <a:latin typeface="Palatino Linotype" panose="02040502050505030304" pitchFamily="18" charset="0"/>
              </a:rPr>
              <a:t> </a:t>
            </a:r>
            <a:r>
              <a:rPr lang="fr-FR" sz="1400" dirty="0" err="1">
                <a:latin typeface="Palatino Linotype" panose="02040502050505030304" pitchFamily="18" charset="0"/>
              </a:rPr>
              <a:t>prediction</a:t>
            </a:r>
            <a:r>
              <a:rPr lang="fr-FR" sz="1400" dirty="0">
                <a:latin typeface="Palatino Linotype" panose="02040502050505030304" pitchFamily="18" charset="0"/>
              </a:rPr>
              <a:t>.</a:t>
            </a:r>
          </a:p>
          <a:p>
            <a:endParaRPr lang="fr-FR" sz="18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411452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>
            <a:extLst>
              <a:ext uri="{FF2B5EF4-FFF2-40B4-BE49-F238E27FC236}">
                <a16:creationId xmlns:a16="http://schemas.microsoft.com/office/drawing/2014/main" id="{473251CD-64C7-DA97-81D7-89D2B5DBEDFC}"/>
              </a:ext>
            </a:extLst>
          </p:cNvPr>
          <p:cNvSpPr txBox="1"/>
          <p:nvPr/>
        </p:nvSpPr>
        <p:spPr>
          <a:xfrm>
            <a:off x="4758813" y="6243484"/>
            <a:ext cx="36084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TaDGK5 : </a:t>
            </a:r>
            <a:r>
              <a:rPr lang="fr-FR" sz="1800" u="sng" dirty="0">
                <a:solidFill>
                  <a:srgbClr val="0000FF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hlinkClick r:id="rId2"/>
              </a:rPr>
              <a:t>A0A3B6DL62</a:t>
            </a:r>
            <a:endParaRPr lang="fr-FR" dirty="0"/>
          </a:p>
        </p:txBody>
      </p:sp>
      <p:pic>
        <p:nvPicPr>
          <p:cNvPr id="3" name="Image 2" descr="Une image contenant léger, art, obscurité, Bleu Majorelle&#10;&#10;Description générée automatiquement">
            <a:extLst>
              <a:ext uri="{FF2B5EF4-FFF2-40B4-BE49-F238E27FC236}">
                <a16:creationId xmlns:a16="http://schemas.microsoft.com/office/drawing/2014/main" id="{A24FA0DD-C43F-D67C-DD28-E2B43218701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535" t="14233" r="32163" b="4341"/>
          <a:stretch/>
        </p:blipFill>
        <p:spPr>
          <a:xfrm>
            <a:off x="3234813" y="127820"/>
            <a:ext cx="5309419" cy="5914482"/>
          </a:xfrm>
          <a:prstGeom prst="rect">
            <a:avLst/>
          </a:prstGeom>
        </p:spPr>
      </p:pic>
      <p:pic>
        <p:nvPicPr>
          <p:cNvPr id="2" name="Image 1">
            <a:extLst>
              <a:ext uri="{FF2B5EF4-FFF2-40B4-BE49-F238E27FC236}">
                <a16:creationId xmlns:a16="http://schemas.microsoft.com/office/drawing/2014/main" id="{2B5E04B4-937D-873D-8C48-BC4C84F6036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0"/>
            <a:ext cx="2781300" cy="2578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700909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>
            <a:extLst>
              <a:ext uri="{FF2B5EF4-FFF2-40B4-BE49-F238E27FC236}">
                <a16:creationId xmlns:a16="http://schemas.microsoft.com/office/drawing/2014/main" id="{473251CD-64C7-DA97-81D7-89D2B5DBEDFC}"/>
              </a:ext>
            </a:extLst>
          </p:cNvPr>
          <p:cNvSpPr txBox="1"/>
          <p:nvPr/>
        </p:nvSpPr>
        <p:spPr>
          <a:xfrm>
            <a:off x="4758813" y="6243484"/>
            <a:ext cx="36084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TaPI-PLC2_1A : </a:t>
            </a:r>
            <a:r>
              <a:rPr lang="fr-FR" sz="1800" u="sng" dirty="0">
                <a:solidFill>
                  <a:srgbClr val="0000FF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hlinkClick r:id="rId2"/>
              </a:rPr>
              <a:t>A0A3B5ZPA1</a:t>
            </a:r>
            <a:endParaRPr lang="fr-FR" dirty="0"/>
          </a:p>
        </p:txBody>
      </p:sp>
      <p:pic>
        <p:nvPicPr>
          <p:cNvPr id="4" name="Image 3" descr="Une image contenant art, Bleu Majorelle, Bleu électrique, capture d’écran&#10;&#10;Description générée automatiquement">
            <a:extLst>
              <a:ext uri="{FF2B5EF4-FFF2-40B4-BE49-F238E27FC236}">
                <a16:creationId xmlns:a16="http://schemas.microsoft.com/office/drawing/2014/main" id="{6377B030-84E0-1183-24D3-2F43437DF86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522" r="23340"/>
          <a:stretch/>
        </p:blipFill>
        <p:spPr>
          <a:xfrm>
            <a:off x="2623395" y="-325410"/>
            <a:ext cx="7580670" cy="6753560"/>
          </a:xfrm>
          <a:prstGeom prst="rect">
            <a:avLst/>
          </a:prstGeom>
        </p:spPr>
      </p:pic>
      <p:pic>
        <p:nvPicPr>
          <p:cNvPr id="2" name="Image 1">
            <a:extLst>
              <a:ext uri="{FF2B5EF4-FFF2-40B4-BE49-F238E27FC236}">
                <a16:creationId xmlns:a16="http://schemas.microsoft.com/office/drawing/2014/main" id="{E559725F-2DB2-5043-DBE5-2175682EACE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0"/>
            <a:ext cx="2781300" cy="2578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0127435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>
            <a:extLst>
              <a:ext uri="{FF2B5EF4-FFF2-40B4-BE49-F238E27FC236}">
                <a16:creationId xmlns:a16="http://schemas.microsoft.com/office/drawing/2014/main" id="{473251CD-64C7-DA97-81D7-89D2B5DBEDFC}"/>
              </a:ext>
            </a:extLst>
          </p:cNvPr>
          <p:cNvSpPr txBox="1"/>
          <p:nvPr/>
        </p:nvSpPr>
        <p:spPr>
          <a:xfrm>
            <a:off x="4758813" y="6243484"/>
            <a:ext cx="36084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TaPLD1 : </a:t>
            </a:r>
            <a:r>
              <a:rPr lang="fr-FR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0A3B5YR57</a:t>
            </a:r>
            <a:endParaRPr lang="fr-FR" dirty="0"/>
          </a:p>
        </p:txBody>
      </p:sp>
      <p:pic>
        <p:nvPicPr>
          <p:cNvPr id="3" name="Image 2" descr="Une image contenant art, Art fractal, Bleu Majorelle, Caractère coloré&#10;&#10;Description générée automatiquement">
            <a:extLst>
              <a:ext uri="{FF2B5EF4-FFF2-40B4-BE49-F238E27FC236}">
                <a16:creationId xmlns:a16="http://schemas.microsoft.com/office/drawing/2014/main" id="{356EC281-4E30-BEF9-9683-769FD3F7CDA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610" r="30265"/>
          <a:stretch/>
        </p:blipFill>
        <p:spPr>
          <a:xfrm>
            <a:off x="2713703" y="-515655"/>
            <a:ext cx="6420465" cy="6943805"/>
          </a:xfrm>
          <a:prstGeom prst="rect">
            <a:avLst/>
          </a:prstGeom>
        </p:spPr>
      </p:pic>
      <p:pic>
        <p:nvPicPr>
          <p:cNvPr id="2" name="Image 1">
            <a:extLst>
              <a:ext uri="{FF2B5EF4-FFF2-40B4-BE49-F238E27FC236}">
                <a16:creationId xmlns:a16="http://schemas.microsoft.com/office/drawing/2014/main" id="{1E4B5D64-E590-F6E8-31B7-FF4EE0AE27B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0"/>
            <a:ext cx="2781300" cy="2578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1430261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>
            <a:extLst>
              <a:ext uri="{FF2B5EF4-FFF2-40B4-BE49-F238E27FC236}">
                <a16:creationId xmlns:a16="http://schemas.microsoft.com/office/drawing/2014/main" id="{473251CD-64C7-DA97-81D7-89D2B5DBEDFC}"/>
              </a:ext>
            </a:extLst>
          </p:cNvPr>
          <p:cNvSpPr txBox="1"/>
          <p:nvPr/>
        </p:nvSpPr>
        <p:spPr>
          <a:xfrm>
            <a:off x="4758813" y="6243484"/>
            <a:ext cx="36084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TaPLD9 : </a:t>
            </a:r>
            <a:r>
              <a:rPr lang="fr-FR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0A3B5ZUY7</a:t>
            </a:r>
            <a:endParaRPr lang="fr-FR" dirty="0"/>
          </a:p>
        </p:txBody>
      </p:sp>
      <p:pic>
        <p:nvPicPr>
          <p:cNvPr id="4" name="Image 3" descr="Une image contenant obscurité, art, capture d’écran, léger&#10;&#10;Description générée automatiquement">
            <a:extLst>
              <a:ext uri="{FF2B5EF4-FFF2-40B4-BE49-F238E27FC236}">
                <a16:creationId xmlns:a16="http://schemas.microsoft.com/office/drawing/2014/main" id="{29514CA8-2C01-2FB3-67B6-7DF126EACFA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601" r="29601"/>
          <a:stretch/>
        </p:blipFill>
        <p:spPr>
          <a:xfrm>
            <a:off x="3242187" y="-130355"/>
            <a:ext cx="5707625" cy="6373839"/>
          </a:xfrm>
          <a:prstGeom prst="rect">
            <a:avLst/>
          </a:prstGeom>
        </p:spPr>
      </p:pic>
      <p:pic>
        <p:nvPicPr>
          <p:cNvPr id="2" name="Image 1">
            <a:extLst>
              <a:ext uri="{FF2B5EF4-FFF2-40B4-BE49-F238E27FC236}">
                <a16:creationId xmlns:a16="http://schemas.microsoft.com/office/drawing/2014/main" id="{B60C639C-02DC-FA61-6A1F-904FC28C4AD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0"/>
            <a:ext cx="2781300" cy="2578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9942908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>
            <a:extLst>
              <a:ext uri="{FF2B5EF4-FFF2-40B4-BE49-F238E27FC236}">
                <a16:creationId xmlns:a16="http://schemas.microsoft.com/office/drawing/2014/main" id="{473251CD-64C7-DA97-81D7-89D2B5DBEDFC}"/>
              </a:ext>
            </a:extLst>
          </p:cNvPr>
          <p:cNvSpPr txBox="1"/>
          <p:nvPr/>
        </p:nvSpPr>
        <p:spPr>
          <a:xfrm>
            <a:off x="5043949" y="6279994"/>
            <a:ext cx="36084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TaPLD10 : </a:t>
            </a:r>
            <a:r>
              <a:rPr lang="fr-FR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0A3B5ZZR4</a:t>
            </a:r>
            <a:endParaRPr lang="fr-FR" dirty="0"/>
          </a:p>
        </p:txBody>
      </p:sp>
      <p:pic>
        <p:nvPicPr>
          <p:cNvPr id="3" name="Image 2" descr="Une image contenant art, capture d’écran, Art fractal, obscurité&#10;&#10;Description générée automatiquement">
            <a:extLst>
              <a:ext uri="{FF2B5EF4-FFF2-40B4-BE49-F238E27FC236}">
                <a16:creationId xmlns:a16="http://schemas.microsoft.com/office/drawing/2014/main" id="{9954001C-CD94-3BCA-906E-3199918530C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922" t="16315" r="36053" b="10172"/>
          <a:stretch/>
        </p:blipFill>
        <p:spPr>
          <a:xfrm>
            <a:off x="3038168" y="-147484"/>
            <a:ext cx="5830528" cy="6294120"/>
          </a:xfrm>
          <a:prstGeom prst="rect">
            <a:avLst/>
          </a:prstGeom>
        </p:spPr>
      </p:pic>
      <p:pic>
        <p:nvPicPr>
          <p:cNvPr id="2" name="Image 1">
            <a:extLst>
              <a:ext uri="{FF2B5EF4-FFF2-40B4-BE49-F238E27FC236}">
                <a16:creationId xmlns:a16="http://schemas.microsoft.com/office/drawing/2014/main" id="{81176BDD-011B-56FD-B0A6-E95A543E2BB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0"/>
            <a:ext cx="2781300" cy="2578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2157085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116</Words>
  <Application>Microsoft Macintosh PowerPoint</Application>
  <PresentationFormat>Grand écran</PresentationFormat>
  <Paragraphs>8</Paragraphs>
  <Slides>6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6</vt:i4>
      </vt:variant>
    </vt:vector>
  </HeadingPairs>
  <TitlesOfParts>
    <vt:vector size="12" baseType="lpstr">
      <vt:lpstr>Aptos</vt:lpstr>
      <vt:lpstr>Aptos Display</vt:lpstr>
      <vt:lpstr>Arial</vt:lpstr>
      <vt:lpstr>Palatino Linotype</vt:lpstr>
      <vt:lpstr>Times New Roman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Lucas Amokrane</dc:creator>
  <cp:lastModifiedBy>Eric Ruelland</cp:lastModifiedBy>
  <cp:revision>5</cp:revision>
  <dcterms:created xsi:type="dcterms:W3CDTF">2024-05-03T07:29:56Z</dcterms:created>
  <dcterms:modified xsi:type="dcterms:W3CDTF">2024-05-16T10:41:20Z</dcterms:modified>
</cp:coreProperties>
</file>